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6" autoAdjust="0"/>
    <p:restoredTop sz="94660"/>
  </p:normalViewPr>
  <p:slideViewPr>
    <p:cSldViewPr snapToGrid="0">
      <p:cViewPr varScale="1">
        <p:scale>
          <a:sx n="80" d="100"/>
          <a:sy n="80" d="100"/>
        </p:scale>
        <p:origin x="86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17BD7B-AA16-5C77-0A0A-EFC68F2258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9E3CC8-F9CD-203A-4E39-6D752FAA20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769E88-68F4-2C4B-408D-4F956ECF4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B58423-2262-8E91-4580-AF8AB9BC64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70B148-7A78-C017-6DF0-18ECE7B10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985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16F4E-0EA2-50F3-43CF-8FB830D18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656661-566D-8C6A-497E-C38028128B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8902DE-763B-DE5E-B66A-DC737071BF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9941F7-B843-A194-078B-1A894B9F2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5ECC9-1D8B-83F1-09AD-235855BCD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319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99A2F6-EEB7-69AE-02E8-529A4F4BB3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0DD28F-D73F-19E1-F220-F4E6D637C0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89D31D-99EF-9895-A3BE-D98A5311D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CB7CEE-5F81-7553-5408-490470C6B3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E7B0CA-B585-A2B1-FD67-7545C58AE4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27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8D12DD-9508-2892-C186-64F8220ED9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95D33D-E8C9-03D8-E557-1FBCB180F8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27F7A3-5767-6424-7791-49CDB6EF5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24A946-627F-4E8F-6A47-D43896A36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C57464-042C-8EFF-2182-8F931829E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26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D6AF8-B102-540C-3198-752C734596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9B11E4-85DA-816B-D3CE-5EDEB0765C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647457-F09D-7258-7869-1253DCAF5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338307-F2AD-901B-77CB-CCB9400E2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93D93E-D102-F361-6487-060F177F4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700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4C7EFF-9567-CDDC-44AC-BC42B55165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CC023D-CE86-8F43-C25D-655E8E22B9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56BC6F-62CF-5FC5-DD9D-CB731DF78F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192ADC-5F26-3A66-F798-CFD89E41D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96DE98-2E15-6014-184D-65D602444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B6791A-0F1F-490C-36AE-700D15FC0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052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F19B9E-669C-D8CB-C346-B2C2CCCBF2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869816-84FF-9E4A-F143-0E9F34B167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B1388A-3A51-45BE-6F5D-4FC8CD18EC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6628D0-676C-8354-64F3-FD6D3D5281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3D1DA1E-24F8-9067-D2B7-053960D0BA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BEF2DC-7CA7-4164-19BC-C0E309BDD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39DE033-6DA6-5071-9EC3-4102BC51F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3B0190-83BC-09E1-661A-9BEDDA153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502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02D913-05D7-329E-A0B8-C8FCD2ED67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02E18F-A400-F99A-014D-A220881BC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8B351E-7E4E-CC5E-0F89-78CFA780F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6BF998-B490-20E0-2D34-2B52E32CD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23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27F6BA-5176-213F-0549-B99A4ECD2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C633FA-F147-D3F7-5A60-8913D7EF1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8BFB6A-58BC-729E-6CA1-96A406285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22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37C642-9A38-DE20-17A3-1C9E5A6415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697FE4-05D1-BBB1-89E6-BCA536E8EE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80D4A2-9F77-2A3A-280E-6C3C93156C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9F43A3-CB53-CAF7-D431-9BDE28172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70376B-0939-C854-8C08-5493A20C5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E90738-A123-E5E5-2CE5-51D896C1C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066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0BBB9F-CBCC-94D4-760C-36A626C87F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418BD79-D40C-0BE4-A913-0CBC66AA46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717FEA-2851-B925-EF37-D8B32B4651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92FB87-0AF5-73B1-DFA0-A4BA957A5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6263C9-4689-EBE9-72B1-776C2C7BA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AFA6DF-E625-36AC-164C-8B2BB6A43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76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DF0996-47D9-51D1-A32E-A4EE1EAB8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3D488C-3300-DE26-0BA4-E99A2D082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6CC0D0-2A7D-CE45-8690-BA58F92340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B06F4B-3D11-4E69-A7F1-EA2BFC41967F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52706A-571C-C77A-6546-0EC8E4696D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7A8446-79FB-F89F-C610-07930E6977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DD7566-4147-4486-A2DC-9DB025040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178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B62A35D-DF84-1D9D-D929-DF297F1148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5407" y="0"/>
            <a:ext cx="3014063" cy="6172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437DEF3-4F1E-33C2-69B5-3114BB8BDC25}"/>
              </a:ext>
            </a:extLst>
          </p:cNvPr>
          <p:cNvSpPr txBox="1"/>
          <p:nvPr/>
        </p:nvSpPr>
        <p:spPr>
          <a:xfrm>
            <a:off x="560158" y="6107498"/>
            <a:ext cx="1133398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</a:rPr>
              <a:t>Supplementary Figure 1 – Long-term patient reported outcomes following autologous BMC treatment for RC tears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</a:rPr>
              <a:t>Shoulder (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</a:rPr>
              <a:t>A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</a:rPr>
              <a:t>) function (DASH), (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</a:rPr>
              <a:t>B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</a:rPr>
              <a:t>) pain (NPS), and (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</a:rPr>
              <a:t>C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</a:rPr>
              <a:t>) percent improvement (SANE) at baseline and 3-, 4-, and 5-year follow-up timepoints from patients opting to provide ongoing outcome data upon study completion. Lines represent </a:t>
            </a:r>
            <a:r>
              <a:rPr lang="en-US" sz="1400" dirty="0">
                <a:solidFill>
                  <a:schemeClr val="accent4"/>
                </a:solidFill>
                <a:latin typeface="Calibri" panose="020F0502020204030204" pitchFamily="34" charset="0"/>
              </a:rPr>
              <a:t>median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</a:rPr>
              <a:t> values (n = displayed).  </a:t>
            </a:r>
            <a:endParaRPr lang="en-US" sz="1400" dirty="0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1017032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7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hren Dodson</dc:creator>
  <cp:lastModifiedBy>Ehren Dodson</cp:lastModifiedBy>
  <cp:revision>1</cp:revision>
  <dcterms:created xsi:type="dcterms:W3CDTF">2024-04-25T16:13:49Z</dcterms:created>
  <dcterms:modified xsi:type="dcterms:W3CDTF">2024-04-25T16:23:57Z</dcterms:modified>
</cp:coreProperties>
</file>